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8" r:id="rId3"/>
    <p:sldId id="262" r:id="rId4"/>
    <p:sldId id="263" r:id="rId5"/>
    <p:sldId id="259" r:id="rId6"/>
    <p:sldId id="260" r:id="rId7"/>
  </p:sldIdLst>
  <p:sldSz cx="12192000" cy="6858000"/>
  <p:notesSz cx="6858000" cy="9144000"/>
  <p:defaultTextStyle>
    <a:defPPr>
      <a:defRPr lang="ko-Kore-K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 varScale="1">
        <p:scale>
          <a:sx n="115" d="100"/>
          <a:sy n="115" d="100"/>
        </p:scale>
        <p:origin x="39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F792AB8-2D79-379F-0612-64EFC573D68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CA686B99-012E-F488-89B2-F4CA9E0DF45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ko-KR" altLang="en-US"/>
              <a:t>클릭하여 마스터 부제목 스타일 편집</a:t>
            </a:r>
            <a:endParaRPr kumimoji="1" lang="ko-Kore-KR" alt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8884FC8-CF17-F917-9A6D-907C1A4E63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A5189-59C8-3648-8C74-7312A4777FDC}" type="datetimeFigureOut">
              <a:rPr kumimoji="1" lang="ko-Kore-KR" altLang="en-US" smtClean="0"/>
              <a:t>12/25/2023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AF5EF01-AC7B-E65A-73BF-3DF43D2B8D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6AB5CBC-C7E2-DF0B-BADB-8DF37DC182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1C52C-4630-844E-A535-784F87173E25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23266956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DA0D725-A53C-9F2E-F4F7-3EAE95FA7D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FB03E2E6-9245-7B7C-2089-06202EAEBC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14C0EAC-EAD3-F381-4DED-95F089A60D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A5189-59C8-3648-8C74-7312A4777FDC}" type="datetimeFigureOut">
              <a:rPr kumimoji="1" lang="ko-Kore-KR" altLang="en-US" smtClean="0"/>
              <a:t>12/25/2023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B6D3173-59DB-684F-8F8E-8DFD8B3EDC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E1BD932-D81B-282B-BCC3-52C088DF52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1C52C-4630-844E-A535-784F87173E25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9384010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CFE0C5FB-D921-7CAE-FEF0-A0DA7128CF8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ADE24AFD-C73E-0A06-9B0C-D886C0EFC7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4860DEF-235F-34C9-5821-E88380750D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A5189-59C8-3648-8C74-7312A4777FDC}" type="datetimeFigureOut">
              <a:rPr kumimoji="1" lang="ko-Kore-KR" altLang="en-US" smtClean="0"/>
              <a:t>12/25/2023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26D9B1C-EB52-9C89-B794-CA35598601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0E0509F-5485-9ACE-4621-A143C3DBA8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1C52C-4630-844E-A535-784F87173E25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4332841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4A60114-38B3-AD38-97B2-B78FBA520C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70BA7B3-26EC-0A97-3896-808864B1A88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AA75A7A-3EC2-167B-B7D8-B3C6261007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A5189-59C8-3648-8C74-7312A4777FDC}" type="datetimeFigureOut">
              <a:rPr kumimoji="1" lang="ko-Kore-KR" altLang="en-US" smtClean="0"/>
              <a:t>12/25/2023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B091D4D-7997-02E6-F15D-DC209FC3E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BA3C823-0208-CA30-3728-A1F5DD289C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1C52C-4630-844E-A535-784F87173E25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2335396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2863D67-0479-ED1A-80F0-B3B1023D94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98A2BDA1-6C52-2216-3D34-3EB4904BA4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00D787D-33F0-90BC-B0CA-3508F3F187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A5189-59C8-3648-8C74-7312A4777FDC}" type="datetimeFigureOut">
              <a:rPr kumimoji="1" lang="ko-Kore-KR" altLang="en-US" smtClean="0"/>
              <a:t>12/25/2023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E38CEBC-2FD8-2CB7-1129-E6DDC09CF6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A7D3BB6-E316-7C4A-9B31-A3E60BAD8E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1C52C-4630-844E-A535-784F87173E25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7848278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E5A0EE5-61A1-A02B-DBBF-6DB4C6537D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88E613F-1B29-68B4-62A4-EB3B480BC6D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F6E9ABF9-496D-CEC5-9358-881DC0648C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406ED05-B71B-7AF5-EC0F-F16309A3CB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A5189-59C8-3648-8C74-7312A4777FDC}" type="datetimeFigureOut">
              <a:rPr kumimoji="1" lang="ko-Kore-KR" altLang="en-US" smtClean="0"/>
              <a:t>12/25/2023</a:t>
            </a:fld>
            <a:endParaRPr kumimoji="1" lang="ko-Kore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C6811479-5A26-A080-1BA8-AE7EF8882B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D402B55-BF11-BC4D-9910-D4BE39341A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1C52C-4630-844E-A535-784F87173E25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42479589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A265C79-D252-FC88-F866-8FB73A7948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739C2DD-442F-C0F7-E9E4-CE96F43B29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6B779AF9-4EFB-646C-F44A-B3AEDB32FC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4B8F36ED-9217-9787-523F-E197880730C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4BF10BDC-BC4F-7DCC-C44A-334AFEFE6F1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F4D6D511-F521-3ECA-3872-AE5E1FBE0C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A5189-59C8-3648-8C74-7312A4777FDC}" type="datetimeFigureOut">
              <a:rPr kumimoji="1" lang="ko-Kore-KR" altLang="en-US" smtClean="0"/>
              <a:t>12/25/2023</a:t>
            </a:fld>
            <a:endParaRPr kumimoji="1" lang="ko-Kore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A42BD153-AE5F-C379-26BE-C3A1FA2447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C7E8B4C2-169E-8629-792E-E6211B0981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1C52C-4630-844E-A535-784F87173E25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4091488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B50F15E-34CA-2078-6135-D6695CFC4A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9BA8A86B-566B-7832-C475-014E85F509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A5189-59C8-3648-8C74-7312A4777FDC}" type="datetimeFigureOut">
              <a:rPr kumimoji="1" lang="ko-Kore-KR" altLang="en-US" smtClean="0"/>
              <a:t>12/25/2023</a:t>
            </a:fld>
            <a:endParaRPr kumimoji="1" lang="ko-Kore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95F4E6FA-7E01-AA25-45BB-08CE9DE971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5F1AB578-FAB8-0B01-8565-A9C8174CAB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1C52C-4630-844E-A535-784F87173E25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8758418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19BDE3C6-DA0C-846C-817C-16E75CE48E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A5189-59C8-3648-8C74-7312A4777FDC}" type="datetimeFigureOut">
              <a:rPr kumimoji="1" lang="ko-Kore-KR" altLang="en-US" smtClean="0"/>
              <a:t>12/25/2023</a:t>
            </a:fld>
            <a:endParaRPr kumimoji="1" lang="ko-Kore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0F686C48-8399-86BF-CC0A-8BF44B9960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00CC05E1-772B-C3A1-97B8-69D6920E9F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1C52C-4630-844E-A535-784F87173E25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3925062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68CCC22-AAD4-A398-C437-A917660940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2D7795B7-4B05-C1C5-DBB9-C2FB1342E1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D15BE294-AF8C-432F-F809-1D19BC2956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35D9683A-8EDE-C7B8-5C79-01E06D9287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A5189-59C8-3648-8C74-7312A4777FDC}" type="datetimeFigureOut">
              <a:rPr kumimoji="1" lang="ko-Kore-KR" altLang="en-US" smtClean="0"/>
              <a:t>12/25/2023</a:t>
            </a:fld>
            <a:endParaRPr kumimoji="1" lang="ko-Kore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8EF77971-581D-956E-DC71-ECF140B802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AF238F6-6D42-32B7-79AD-30F09CC1D7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1C52C-4630-844E-A535-784F87173E25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28177291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B918EDA-C43C-93ED-631B-9B0FFCF442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5EAA11C1-031D-C47D-90D9-0CD6AD52BA2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ko-Kore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EA1FFF53-6CBD-37FB-2A22-45F533C1F4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0B6888F-2A67-22DD-0DA7-D12ECE59A6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A5189-59C8-3648-8C74-7312A4777FDC}" type="datetimeFigureOut">
              <a:rPr kumimoji="1" lang="ko-Kore-KR" altLang="en-US" smtClean="0"/>
              <a:t>12/25/2023</a:t>
            </a:fld>
            <a:endParaRPr kumimoji="1" lang="ko-Kore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32AE8F78-5313-C719-D0ED-CB136F3DAE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492CF927-3AD2-8CFD-194A-DBF48987C5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1C52C-4630-844E-A535-784F87173E25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7912880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A3B45243-FE9C-29CA-33D8-169C6B9309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87F28D4-CD4F-3CB5-E7D5-51C32A84BF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1A66151-8282-9EB1-1091-2065B6BC06C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3A5189-59C8-3648-8C74-7312A4777FDC}" type="datetimeFigureOut">
              <a:rPr kumimoji="1" lang="ko-Kore-KR" altLang="en-US" smtClean="0"/>
              <a:t>12/25/2023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F26A73E-DBD2-5052-4C5C-ED00428AE85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699CCEC-3F01-8A2E-EBB0-B1623CD8219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F1C52C-4630-844E-A535-784F87173E25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5706726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ore-K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8D2E9694-DF1E-0172-2FA0-1CB6BB9BFA4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49895" y="1003309"/>
            <a:ext cx="8892209" cy="550424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3642BA3-CB32-E5A2-D480-3296C124836C}"/>
              </a:ext>
            </a:extLst>
          </p:cNvPr>
          <p:cNvSpPr txBox="1"/>
          <p:nvPr/>
        </p:nvSpPr>
        <p:spPr>
          <a:xfrm>
            <a:off x="444775" y="350443"/>
            <a:ext cx="1091565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altLang="ko-Kore-KR" sz="1800" b="1" dirty="0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Supplementary Figure </a:t>
            </a:r>
            <a:r>
              <a:rPr lang="en-US" altLang="ko-Kore-KR" sz="1800" b="1" dirty="0" smtClean="0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S1.</a:t>
            </a:r>
            <a:r>
              <a:rPr lang="en-US" altLang="ko-Kore-KR" sz="1800" dirty="0" smtClean="0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 </a:t>
            </a:r>
            <a:r>
              <a:rPr lang="en-US" altLang="ko-Kore-KR" sz="1800" dirty="0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Transposable Elements (TE) divergence distribution using Kimura Distance analysis.</a:t>
            </a:r>
            <a:endParaRPr lang="ko-Kore-KR" altLang="ko-Kore-KR" sz="1800" dirty="0">
              <a:effectLst/>
              <a:latin typeface="Times New Roman" panose="02020603050405020304" pitchFamily="18" charset="0"/>
              <a:ea typeface="맑은 고딕" panose="020B0503020000020004" pitchFamily="34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222222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5DAFCF97-DB31-37BD-79C0-CCBB485AFF6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4243" y="1002633"/>
            <a:ext cx="10663514" cy="533175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59DD4847-7103-55E4-0BBA-35B8BCC76253}"/>
              </a:ext>
            </a:extLst>
          </p:cNvPr>
          <p:cNvSpPr txBox="1"/>
          <p:nvPr/>
        </p:nvSpPr>
        <p:spPr>
          <a:xfrm>
            <a:off x="444775" y="350443"/>
            <a:ext cx="1091565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altLang="ko-Kore-KR" sz="1800" b="1" dirty="0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Supplementary Figure </a:t>
            </a:r>
            <a:r>
              <a:rPr lang="en-US" altLang="ko-Kore-KR" sz="1800" b="1" dirty="0" smtClean="0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S</a:t>
            </a:r>
            <a:r>
              <a:rPr lang="en-US" altLang="ko-Kore-KR" b="1" dirty="0"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2</a:t>
            </a:r>
            <a:r>
              <a:rPr lang="en-US" altLang="ko-Kore-KR" sz="1800" b="1" dirty="0" smtClean="0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.</a:t>
            </a:r>
            <a:r>
              <a:rPr lang="ko-KR" altLang="en-US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 </a:t>
            </a:r>
            <a:r>
              <a:rPr lang="en-US" altLang="ko-Kore-KR" sz="1800" dirty="0">
                <a:effectLst/>
                <a:latin typeface="Times New Roman" panose="02020603050405020304" pitchFamily="18" charset="0"/>
                <a:ea typeface="맑은 고딕" panose="020B0503020000020004" pitchFamily="34" charset="-127"/>
              </a:rPr>
              <a:t>Distribution of the number of Geno Ontology annotations at each GO level.</a:t>
            </a:r>
            <a:r>
              <a:rPr lang="ko-Kore-KR" altLang="ko-Kore-KR" dirty="0">
                <a:effectLst/>
              </a:rPr>
              <a:t>  </a:t>
            </a:r>
            <a:endParaRPr lang="ko-Kore-KR" altLang="ko-Kore-KR" sz="1800" dirty="0">
              <a:effectLst/>
              <a:latin typeface="Times New Roman" panose="02020603050405020304" pitchFamily="18" charset="0"/>
              <a:ea typeface="맑은 고딕" panose="020B0503020000020004" pitchFamily="34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14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292C5C5-8D57-5CB7-64D9-7CAAC83D33DA}"/>
              </a:ext>
            </a:extLst>
          </p:cNvPr>
          <p:cNvSpPr txBox="1"/>
          <p:nvPr/>
        </p:nvSpPr>
        <p:spPr>
          <a:xfrm>
            <a:off x="444775" y="350443"/>
            <a:ext cx="1091565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altLang="ko-Kore-KR" sz="1800" b="1" dirty="0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Supplementary Figure </a:t>
            </a:r>
            <a:r>
              <a:rPr lang="en-US" altLang="ko-Kore-KR" sz="1800" b="1" dirty="0" smtClean="0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S</a:t>
            </a:r>
            <a:r>
              <a:rPr lang="en-US" altLang="ko-Kore-KR" b="1" dirty="0" smtClean="0"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3</a:t>
            </a:r>
            <a:r>
              <a:rPr lang="en-US" altLang="ko-Kore-KR" sz="1800" b="1" dirty="0" smtClean="0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.</a:t>
            </a:r>
            <a:r>
              <a:rPr lang="ko-KR" altLang="en-US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 </a:t>
            </a:r>
            <a:r>
              <a:rPr lang="en-US" altLang="ko-KR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Distribution of number of genes per </a:t>
            </a:r>
            <a:r>
              <a:rPr lang="en-US" altLang="ko-KR" dirty="0" err="1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orthogroup</a:t>
            </a:r>
            <a:r>
              <a:rPr lang="en-US" altLang="ko-KR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 for four </a:t>
            </a:r>
            <a:r>
              <a:rPr lang="en-US" altLang="ko-KR" i="1" dirty="0" err="1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C.sinensis</a:t>
            </a:r>
            <a:r>
              <a:rPr lang="en-US" altLang="ko-KR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 species</a:t>
            </a:r>
            <a:endParaRPr lang="ko-Kore-KR" altLang="ko-Kore-KR" sz="1800" dirty="0">
              <a:effectLst/>
              <a:latin typeface="Times New Roman" panose="02020603050405020304" pitchFamily="18" charset="0"/>
              <a:ea typeface="맑은 고딕" panose="020B0503020000020004" pitchFamily="34" charset="-127"/>
              <a:cs typeface="Times New Roman" panose="02020603050405020304" pitchFamily="18" charset="0"/>
            </a:endParaRPr>
          </a:p>
        </p:txBody>
      </p:sp>
      <p:pic>
        <p:nvPicPr>
          <p:cNvPr id="6" name="그림 5">
            <a:extLst>
              <a:ext uri="{FF2B5EF4-FFF2-40B4-BE49-F238E27FC236}">
                <a16:creationId xmlns:a16="http://schemas.microsoft.com/office/drawing/2014/main" id="{1FC13638-EB77-6BF1-BDB4-0831D60D76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94919" y="1253352"/>
            <a:ext cx="6755407" cy="52542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965023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5700FB21-F2E1-1FA1-C3F6-62EE7A39CA6D}"/>
              </a:ext>
            </a:extLst>
          </p:cNvPr>
          <p:cNvSpPr txBox="1"/>
          <p:nvPr/>
        </p:nvSpPr>
        <p:spPr>
          <a:xfrm>
            <a:off x="444775" y="325505"/>
            <a:ext cx="1091565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altLang="ko-Kore-KR" sz="1800" b="1" dirty="0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Supplementary Figure </a:t>
            </a:r>
            <a:r>
              <a:rPr lang="en-US" altLang="ko-Kore-KR" sz="1800" b="1" dirty="0" smtClean="0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S</a:t>
            </a:r>
            <a:r>
              <a:rPr lang="en-US" altLang="ko-Kore-KR" b="1" dirty="0"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4</a:t>
            </a:r>
            <a:r>
              <a:rPr lang="en-US" altLang="ko-Kore-KR" sz="1800" b="1" dirty="0" smtClean="0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.</a:t>
            </a:r>
            <a:r>
              <a:rPr lang="ko-KR" altLang="en-US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 </a:t>
            </a:r>
            <a:r>
              <a:rPr lang="en-US" altLang="ko-KR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Summary of </a:t>
            </a:r>
            <a:r>
              <a:rPr lang="en-US" altLang="ko-KR" dirty="0" smtClean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551 Catechin </a:t>
            </a:r>
            <a:r>
              <a:rPr lang="en-US" altLang="ko-KR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genes for Sangmok species</a:t>
            </a:r>
            <a:endParaRPr lang="ko-Kore-KR" altLang="ko-Kore-KR" sz="1800" dirty="0">
              <a:effectLst/>
              <a:latin typeface="Times New Roman" panose="02020603050405020304" pitchFamily="18" charset="0"/>
              <a:ea typeface="맑은 고딕" panose="020B0503020000020004" pitchFamily="34" charset="-127"/>
              <a:cs typeface="Times New Roman" panose="02020603050405020304" pitchFamily="18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73050" y="870931"/>
            <a:ext cx="5629275" cy="5581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179653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59DD4847-7103-55E4-0BBA-35B8BCC76253}"/>
              </a:ext>
            </a:extLst>
          </p:cNvPr>
          <p:cNvSpPr txBox="1"/>
          <p:nvPr/>
        </p:nvSpPr>
        <p:spPr>
          <a:xfrm>
            <a:off x="444775" y="350443"/>
            <a:ext cx="1091565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altLang="ko-Kore-KR" sz="1800" b="1" dirty="0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Supplementary Figure </a:t>
            </a:r>
            <a:r>
              <a:rPr lang="en-US" altLang="ko-Kore-KR" sz="1800" b="1" dirty="0" smtClean="0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S</a:t>
            </a:r>
            <a:r>
              <a:rPr lang="en-US" altLang="ko-Kore-KR" b="1" dirty="0"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5</a:t>
            </a:r>
            <a:r>
              <a:rPr lang="en-US" altLang="ko-Kore-KR" sz="1800" b="1" dirty="0" smtClean="0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.</a:t>
            </a:r>
            <a:r>
              <a:rPr lang="ko-KR" altLang="en-US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 </a:t>
            </a:r>
            <a:r>
              <a:rPr lang="en-US" altLang="ko-Kore-KR" dirty="0">
                <a:latin typeface="Times New Roman" panose="02020603050405020304" pitchFamily="18" charset="0"/>
                <a:ea typeface="맑은 고딕" panose="020B0503020000020004" pitchFamily="34" charset="-127"/>
              </a:rPr>
              <a:t>17 Sangmok-specific genes have </a:t>
            </a:r>
            <a:r>
              <a:rPr lang="en-US" altLang="ko-Kore-KR" dirty="0" smtClean="0">
                <a:latin typeface="Times New Roman" panose="02020603050405020304" pitchFamily="18" charset="0"/>
                <a:ea typeface="맑은 고딕" panose="020B0503020000020004" pitchFamily="34" charset="-127"/>
              </a:rPr>
              <a:t>been expression </a:t>
            </a:r>
            <a:r>
              <a:rPr lang="en-US" altLang="ko-Kore-KR" dirty="0">
                <a:latin typeface="Times New Roman" panose="02020603050405020304" pitchFamily="18" charset="0"/>
                <a:ea typeface="맑은 고딕" panose="020B0503020000020004" pitchFamily="34" charset="-127"/>
              </a:rPr>
              <a:t>via </a:t>
            </a:r>
            <a:r>
              <a:rPr lang="en-US" altLang="ko-Kore-KR" dirty="0" err="1">
                <a:latin typeface="Times New Roman" panose="02020603050405020304" pitchFamily="18" charset="0"/>
                <a:ea typeface="맑은 고딕" panose="020B0503020000020004" pitchFamily="34" charset="-127"/>
              </a:rPr>
              <a:t>qRT</a:t>
            </a:r>
            <a:r>
              <a:rPr lang="en-US" altLang="ko-Kore-KR" dirty="0">
                <a:latin typeface="Times New Roman" panose="02020603050405020304" pitchFamily="18" charset="0"/>
                <a:ea typeface="맑은 고딕" panose="020B0503020000020004" pitchFamily="34" charset="-127"/>
              </a:rPr>
              <a:t>-PCR.</a:t>
            </a:r>
            <a:r>
              <a:rPr lang="ko-Kore-KR" altLang="ko-Kore-KR" dirty="0" smtClean="0">
                <a:effectLst/>
              </a:rPr>
              <a:t>  </a:t>
            </a:r>
            <a:endParaRPr lang="ko-Kore-KR" altLang="ko-Kore-KR" sz="1800" dirty="0">
              <a:effectLst/>
              <a:latin typeface="Times New Roman" panose="02020603050405020304" pitchFamily="18" charset="0"/>
              <a:ea typeface="맑은 고딕" panose="020B0503020000020004" pitchFamily="34" charset="-127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3040" y="899723"/>
            <a:ext cx="8470929" cy="58502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8497276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59DD4847-7103-55E4-0BBA-35B8BCC76253}"/>
              </a:ext>
            </a:extLst>
          </p:cNvPr>
          <p:cNvSpPr txBox="1"/>
          <p:nvPr/>
        </p:nvSpPr>
        <p:spPr>
          <a:xfrm>
            <a:off x="444775" y="350443"/>
            <a:ext cx="1091565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altLang="ko-Kore-KR" sz="1800" b="1" dirty="0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Supplementary Figure </a:t>
            </a:r>
            <a:r>
              <a:rPr lang="en-US" altLang="ko-Kore-KR" sz="1800" b="1" dirty="0" smtClean="0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S</a:t>
            </a:r>
            <a:r>
              <a:rPr lang="en-US" altLang="ko-Kore-KR" b="1" dirty="0"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6</a:t>
            </a:r>
            <a:r>
              <a:rPr lang="en-US" altLang="ko-Kore-KR" sz="1800" b="1" dirty="0" smtClean="0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.</a:t>
            </a:r>
            <a:r>
              <a:rPr lang="ko-KR" altLang="en-US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 </a:t>
            </a:r>
            <a:r>
              <a:rPr lang="en-US" altLang="ko-Kore-KR" dirty="0">
                <a:latin typeface="Times New Roman" panose="02020603050405020304" pitchFamily="18" charset="0"/>
                <a:ea typeface="맑은 고딕" panose="020B0503020000020004" pitchFamily="34" charset="-127"/>
              </a:rPr>
              <a:t>Registration of PVP Right (Application Number 2011-426) in Korea Seed &amp; Variety </a:t>
            </a:r>
            <a:r>
              <a:rPr lang="en-US" altLang="ko-Kore-KR" dirty="0" smtClean="0">
                <a:latin typeface="Times New Roman" panose="02020603050405020304" pitchFamily="18" charset="0"/>
                <a:ea typeface="맑은 고딕" panose="020B0503020000020004" pitchFamily="34" charset="-127"/>
              </a:rPr>
              <a:t>Service</a:t>
            </a:r>
            <a:endParaRPr lang="ko-Kore-KR" altLang="ko-Kore-KR" sz="1800" dirty="0">
              <a:effectLst/>
              <a:latin typeface="Times New Roman" panose="02020603050405020304" pitchFamily="18" charset="0"/>
              <a:ea typeface="맑은 고딕" panose="020B0503020000020004" pitchFamily="34" charset="-127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2143" y="1163782"/>
            <a:ext cx="5149988" cy="3442594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85981" y="1188418"/>
            <a:ext cx="5520548" cy="3009509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035935" y="4197927"/>
            <a:ext cx="2780520" cy="2249886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7195" y="4721896"/>
            <a:ext cx="5224520" cy="1811908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7686676" y="3476625"/>
            <a:ext cx="1162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Sangmok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7997528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3</TotalTime>
  <Words>93</Words>
  <Application>Microsoft Office PowerPoint</Application>
  <PresentationFormat>와이드스크린</PresentationFormat>
  <Paragraphs>7</Paragraphs>
  <Slides>6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6</vt:i4>
      </vt:variant>
    </vt:vector>
  </HeadingPairs>
  <TitlesOfParts>
    <vt:vector size="13" baseType="lpstr">
      <vt:lpstr>맑은 고딕</vt:lpstr>
      <vt:lpstr>Arial</vt:lpstr>
      <vt:lpstr>Calibri</vt:lpstr>
      <vt:lpstr>Calibri Light</vt:lpstr>
      <vt:lpstr>Palatino Linotype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Lee Seung Jae</dc:creator>
  <cp:lastModifiedBy>Dong-Jun Lee</cp:lastModifiedBy>
  <cp:revision>23</cp:revision>
  <dcterms:created xsi:type="dcterms:W3CDTF">2022-10-17T07:43:26Z</dcterms:created>
  <dcterms:modified xsi:type="dcterms:W3CDTF">2023-12-25T03:54:53Z</dcterms:modified>
</cp:coreProperties>
</file>